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</p:sldIdLst>
  <p:sldSz cx="10188575" cy="72072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69500-E43E-4487-9D6F-4103A56E60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916776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9760" y="4165200"/>
            <a:ext cx="916776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F6723-3083-408C-BD51-D659A6512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07400" y="168084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9760" y="416520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07400" y="416520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9E3A9-2CC5-4A9F-9F52-53BFDCDD0A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295164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609360" y="1680840"/>
            <a:ext cx="295164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708960" y="1680840"/>
            <a:ext cx="295164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9760" y="4165200"/>
            <a:ext cx="295164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609360" y="4165200"/>
            <a:ext cx="295164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708960" y="4165200"/>
            <a:ext cx="295164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20DC1-14A5-4F34-AA4E-BDE65ECD8D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9760" y="1680840"/>
            <a:ext cx="9167760" cy="4755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CC58E-254B-44EC-B03B-B5843C78B2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9167760" cy="475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D5DAF-2250-4B24-B183-1EBA519EEC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4473720" cy="475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07400" y="1680840"/>
            <a:ext cx="4473720" cy="475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088D8-D873-4B93-827B-54C89BF0CD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21E9C-EB22-4713-B7A8-D5B2A2F78A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9760" y="288720"/>
            <a:ext cx="9167760" cy="556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61352-4276-4B63-B034-ED3874ADBA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07400" y="1680840"/>
            <a:ext cx="4473720" cy="475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9760" y="416520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F91A0-E86B-4D57-A19A-B5E4ADDD3A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4473720" cy="475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07400" y="168084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07400" y="416520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9EE19-5D43-4681-A07A-01D727C8DB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9760" y="168084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07400" y="1680840"/>
            <a:ext cx="447372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9760" y="4165200"/>
            <a:ext cx="9167760" cy="22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4D37D-B305-46B7-A057-C383566C75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9760" y="288720"/>
            <a:ext cx="916776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9760" y="1680840"/>
            <a:ext cx="9167760" cy="4755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9400" y="6678360"/>
            <a:ext cx="237636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79400" y="6678360"/>
            <a:ext cx="322740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00800" y="6678360"/>
            <a:ext cx="237672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C4DE59E-FC05-4AF0-93B6-F33A05A9C922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5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87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magine 3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Immagine 1" descr="Figure S3.pdf"/>
          <p:cNvPicPr/>
          <p:nvPr/>
        </p:nvPicPr>
        <p:blipFill>
          <a:blip r:embed="rId1"/>
          <a:stretch/>
        </p:blipFill>
        <p:spPr>
          <a:xfrm>
            <a:off x="0" y="0"/>
            <a:ext cx="10186920" cy="71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26T07:00:45Z</dcterms:created>
  <dc:creator>Erica Di Pierro</dc:creator>
  <dc:description/>
  <dc:language>en-US</dc:language>
  <cp:lastModifiedBy>shanmugam.s</cp:lastModifiedBy>
  <dcterms:modified xsi:type="dcterms:W3CDTF">2016-11-18T16:52:54Z</dcterms:modified>
  <cp:revision>3</cp:revision>
  <dc:subject/>
  <dc:title>Presentazione di PowerPoint</dc:title>
</cp:coreProperties>
</file>